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46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8462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035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7158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5785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4354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0307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2823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9484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0459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1639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5272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4675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332656"/>
            <a:ext cx="5846229" cy="48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ttangolo 2"/>
          <p:cNvSpPr/>
          <p:nvPr/>
        </p:nvSpPr>
        <p:spPr>
          <a:xfrm>
            <a:off x="446382" y="5157192"/>
            <a:ext cx="828092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ocal microscopy analysis of mycobacterial intracellular localization in human macrophag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ages of CD63-stained THP-1-derived macrophages infected with GFP expressing H37Rv, TB218 or and TB382 at an MOI of 1:1. After 48 h of infectio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CD6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tments were stained in red fluorescence using anti-CD63 antibodies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both red and green fluorescence indicates that the mycobacteria reside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63-associated compartment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verlap is demonstrated in the merged images, where yellow indicates a positive correlation. Boxed areas show enlargements of sections of interest with examples of negative (H37Rv and TB318) and positive (TB218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mages were taken with a Leica T CSNT/SP2 confocal microscope using a x63 oil immersion objective. To calculate the percentage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each coverslip, the superposition of fluorescence for a minimum of 100 internalized isolated bacteria was analyzed. At least two slides were analyzed from each of three independent infections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48932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4</Words>
  <Application>Microsoft Office PowerPoint</Application>
  <PresentationFormat>Presentazione su schermo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ccardo</dc:creator>
  <cp:lastModifiedBy>Riccardo</cp:lastModifiedBy>
  <cp:revision>2</cp:revision>
  <dcterms:created xsi:type="dcterms:W3CDTF">2014-09-09T22:22:12Z</dcterms:created>
  <dcterms:modified xsi:type="dcterms:W3CDTF">2014-09-09T22:24:04Z</dcterms:modified>
</cp:coreProperties>
</file>